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0">
              <a:solidFill>
                <a:srgbClr val="000000"/>
              </a:solidFill>
            </a:ln>
          </c:spPr>
          <c:invertIfNegative val="0"/>
          <c:cat>
            <c:strRef>
              <c:f>categories</c:f>
              <c:strCache>
                <c:ptCount val="0"/>
              </c:strCache>
            </c:strRef>
          </c:cat>
        </c:ser>
        <c:gapWidth val="150"/>
        <c:overlap val="0"/>
        <c:axId val="80300213"/>
        <c:axId val="87564322"/>
      </c:barChart>
      <c:catAx>
        <c:axId val="80300213"/>
        <c:scaling>
          <c:orientation val="minMax"/>
        </c:scaling>
        <c:delete val="0"/>
        <c:axPos val="b"/>
        <c:numFmt formatCode="[$-409]mm/dd/yyyy" sourceLinked="1"/>
        <c:majorTickMark val="in"/>
        <c:minorTickMark val="none"/>
        <c:tickLblPos val="nextTo"/>
        <c:spPr>
          <a:ln w="1764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1109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87564322"/>
        <c:crosses val="autoZero"/>
        <c:auto val="1"/>
        <c:lblAlgn val="ctr"/>
        <c:lblOffset val="100"/>
        <c:noMultiLvlLbl val="0"/>
      </c:catAx>
      <c:valAx>
        <c:axId val="87564322"/>
        <c:scaling>
          <c:orientation val="minMax"/>
          <c:max val="150"/>
          <c:min val="0"/>
        </c:scaling>
        <c:delete val="0"/>
        <c:axPos val="l"/>
        <c:majorGridlines>
          <c:spPr>
            <a:ln w="9360">
              <a:solidFill>
                <a:srgbClr val="878787"/>
              </a:solidFill>
              <a:round/>
            </a:ln>
          </c:spPr>
        </c:majorGridlines>
        <c:numFmt formatCode="General" sourceLinked="1"/>
        <c:majorTickMark val="in"/>
        <c:minorTickMark val="none"/>
        <c:tickLblPos val="nextTo"/>
        <c:spPr>
          <a:ln w="17640">
            <a:solidFill>
              <a:srgbClr val="000000"/>
            </a:solidFill>
            <a:round/>
          </a:ln>
        </c:spPr>
        <c:txPr>
          <a:bodyPr/>
          <a:lstStyle/>
          <a:p>
            <a:pPr>
              <a:defRPr b="0" sz="1109" spc="-1" strike="noStrike">
                <a:solidFill>
                  <a:srgbClr val="000000"/>
                </a:solidFill>
                <a:latin typeface="Times New Roman"/>
              </a:defRPr>
            </a:pPr>
          </a:p>
        </c:txPr>
        <c:crossAx val="80300213"/>
        <c:crosses val="autoZero"/>
        <c:crossBetween val="between"/>
        <c:majorUnit val="50"/>
      </c:valAx>
      <c:spPr>
        <a:noFill/>
        <a:ln w="23400">
          <a:noFill/>
        </a:ln>
      </c:spPr>
    </c:plotArea>
    <c:plotVisOnly val="1"/>
    <c:dispBlanksAs val="gap"/>
  </c:chart>
  <c:spPr>
    <a:solidFill>
      <a:srgbClr val="ffffff"/>
    </a:solidFill>
    <a:ln w="9360">
      <a:noFill/>
    </a:ln>
  </c:spPr>
</c:chartSpace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9D69D9B-EC8D-43C2-89D5-21E72201D49D}" type="slidenum">
              <a:t>&lt;#&gt;</a:t>
            </a:fld>
          </a:p>
        </p:txBody>
      </p:sp>
      <p:sp>
        <p:nvSpPr>
          <p:cNvPr id="3" name="PlaceHolder 2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7E53F25-8EB4-4EB9-8F8E-01F658984C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B07C1BD6-3227-4FF4-952B-FB7D3BA252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2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5480" y="213336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30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2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5480" y="5284440"/>
            <a:ext cx="198648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6EB1072A-E09C-4ED8-8822-08C0EDBF0D50}" type="slidenum">
              <a:t>&lt;#&gt;</a:t>
            </a:fld>
          </a:p>
        </p:txBody>
      </p:sp>
      <p:sp>
        <p:nvSpPr>
          <p:cNvPr id="10" name="PlaceHolder 9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B6DA16D-36C3-490E-954A-E4E2E47C53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3611187-ECA7-4433-AC0B-AD8B86677B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8A3F743F-985F-424A-97D5-141B335716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C5CF944C-8D95-4C6F-A772-7F69F584D1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3080" y="366480"/>
            <a:ext cx="6170400" cy="70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D6D49B9F-0ADD-41A0-AFB6-BAFB1906E6F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9A13FC68-5E55-4E88-A40E-54510D606C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4960" y="528444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AC70F0EB-89DE-4D8F-93EB-3E88A8C8A6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308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4960" y="2133360"/>
            <a:ext cx="301104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3080" y="5284440"/>
            <a:ext cx="6170400" cy="2877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2"/>
          </p:nvPr>
        </p:nvSpPr>
        <p:spPr/>
        <p:txBody>
          <a:bodyPr/>
          <a:p>
            <a:fld id="{5831B269-C54B-4C5A-AAB1-B472DD2581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3080" y="366480"/>
            <a:ext cx="6170400" cy="1522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p>
            <a:pPr indent="0">
              <a:lnSpc>
                <a:spcPct val="102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3080" y="2133360"/>
            <a:ext cx="6170400" cy="603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rmAutofit/>
          </a:bodyPr>
          <a:p>
            <a:pPr marL="343080" indent="0">
              <a:lnSpc>
                <a:spcPct val="102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343080" indent="-343080">
              <a:lnSpc>
                <a:spcPct val="102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3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6/27/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2343240" y="8475840"/>
            <a:ext cx="2171520" cy="48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4"/>
          <p:cNvSpPr>
            <a:spLocks noGrp="1"/>
          </p:cNvSpPr>
          <p:nvPr>
            <p:ph type="sldNum" idx="2"/>
          </p:nvPr>
        </p:nvSpPr>
        <p:spPr>
          <a:xfrm>
            <a:off x="4915080" y="8475840"/>
            <a:ext cx="1598400" cy="483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5000" bIns="450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723960"/>
                <a:tab algn="l" pos="144792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DA80796F-9370-4261-81DC-C797F7F63E74}" type="slidenum">
              <a:rPr b="0" lang="en-US" sz="1800" spc="-1" strike="noStrike">
                <a:solidFill>
                  <a:srgbClr val="000000"/>
                </a:solidFill>
                <a:latin typeface="Calibri"/>
                <a:ea typeface="Arial Unicode MS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rot="16200000">
            <a:off x="560520" y="3565440"/>
            <a:ext cx="23508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Relative transcript level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189160" y="3246480"/>
          <a:ext cx="2701800" cy="1293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43" name=""/>
          <p:cNvSpPr/>
          <p:nvPr/>
        </p:nvSpPr>
        <p:spPr>
          <a:xfrm>
            <a:off x="3201840" y="2976480"/>
            <a:ext cx="939600" cy="30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1" i="1" lang="en-US" sz="14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18S r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49200" y="620640"/>
            <a:ext cx="2863800" cy="40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Ishimaru T.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et al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lementary 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382760" y="5292720"/>
            <a:ext cx="4091040" cy="82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Figure S1 qRT-PCR for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18S rRNA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The gene accession numbers and primer pairs are shown in Table 1. Values are the means of three biological replications. The value in each tissue was used for the normalizatio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/>
  <cp:revision>0</cp:revision>
  <dc:subject/>
  <dc:title/>
</cp:coreProperties>
</file>